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4678"/>
  </p:normalViewPr>
  <p:slideViewPr>
    <p:cSldViewPr snapToGrid="0" snapToObjects="1">
      <p:cViewPr>
        <p:scale>
          <a:sx n="90" d="100"/>
          <a:sy n="90" d="100"/>
        </p:scale>
        <p:origin x="586" y="-337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F66767-A7DF-8842-9FD3-E3F79601CD55}" type="datetimeFigureOut">
              <a:rPr kumimoji="1" lang="ja-JP" altLang="en-US" smtClean="0"/>
              <a:t>2017/9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59DCF5-D71F-684E-8E51-311AC04A728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611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691225126"/>
              </p:ext>
            </p:extLst>
          </p:nvPr>
        </p:nvGraphicFramePr>
        <p:xfrm>
          <a:off x="211686" y="974887"/>
          <a:ext cx="6446660" cy="7955727"/>
        </p:xfrm>
        <a:graphic>
          <a:graphicData uri="http://schemas.openxmlformats.org/drawingml/2006/table">
            <a:tbl>
              <a:tblPr/>
              <a:tblGrid>
                <a:gridCol w="139182"/>
                <a:gridCol w="588361"/>
                <a:gridCol w="961623"/>
                <a:gridCol w="594688"/>
                <a:gridCol w="423872"/>
                <a:gridCol w="423872"/>
                <a:gridCol w="423872"/>
                <a:gridCol w="423872"/>
                <a:gridCol w="423872"/>
                <a:gridCol w="423872"/>
                <a:gridCol w="809787"/>
                <a:gridCol w="809787"/>
              </a:tblGrid>
              <a:tr h="108617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 dirty="0">
                          <a:effectLst/>
                          <a:latin typeface="Calibri (テーマの本文)"/>
                        </a:rPr>
                        <a:t>No.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Down-regulated 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smtClean="0">
                          <a:effectLst/>
                          <a:latin typeface="Calibri (テーマの本文)"/>
                        </a:rPr>
                        <a:t>Target</a:t>
                      </a:r>
                      <a:r>
                        <a:rPr lang="en-US" sz="600" b="1" i="0" u="none" strike="noStrike" baseline="0" dirty="0" smtClean="0">
                          <a:effectLst/>
                          <a:latin typeface="Calibri (テーマの本文)"/>
                        </a:rPr>
                        <a:t> </a:t>
                      </a:r>
                      <a:r>
                        <a:rPr lang="en-US" sz="600" b="1" i="0" u="none" strike="noStrike" dirty="0" smtClean="0">
                          <a:effectLst/>
                          <a:latin typeface="Calibri (テーマの本文)"/>
                        </a:rPr>
                        <a:t>genes </a:t>
                      </a:r>
                      <a:endParaRPr lang="en-US" sz="600" b="1" i="0" u="none" strike="noStrike" dirty="0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smtClean="0">
                          <a:effectLst/>
                          <a:latin typeface="Calibri (テーマの本文)"/>
                        </a:rPr>
                        <a:t>Target </a:t>
                      </a:r>
                      <a:r>
                        <a:rPr lang="en-US" sz="600" b="1" i="0" u="none" strike="noStrike" dirty="0">
                          <a:effectLst/>
                          <a:latin typeface="Calibri (テーマの本文)"/>
                        </a:rPr>
                        <a:t>gene is </a:t>
                      </a:r>
                      <a:r>
                        <a:rPr lang="en-US" sz="600" b="1" i="0" u="none" strike="noStrike" dirty="0" smtClean="0">
                          <a:effectLst/>
                          <a:latin typeface="Calibri (テーマの本文)"/>
                        </a:rPr>
                        <a:t>secreted </a:t>
                      </a:r>
                      <a:r>
                        <a:rPr lang="en-US" sz="600" b="1" i="0" u="none" strike="noStrike" dirty="0">
                          <a:effectLst/>
                          <a:latin typeface="Calibri (テーマの本文)"/>
                        </a:rPr>
                        <a:t>protein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 dirty="0" smtClean="0">
                          <a:effectLst/>
                          <a:latin typeface="Calibri (テーマの本文)"/>
                        </a:rPr>
                        <a:t>Function</a:t>
                      </a:r>
                      <a:endParaRPr lang="en-US" sz="600" b="1" i="0" u="none" strike="noStrike" dirty="0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Ref.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08617"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miRNA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(previous report)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growth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500" b="1" i="0" u="none" strike="noStrike" dirty="0">
                          <a:effectLst/>
                          <a:latin typeface="Calibri (テーマの本文)"/>
                        </a:rPr>
                        <a:t>proliferation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migration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invasion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metastasis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apoptosis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Others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600" b="1" i="0" u="none" strike="noStrike">
                          <a:effectLst/>
                          <a:latin typeface="Calibri (テーマの本文)"/>
                        </a:rPr>
                        <a:t>PMID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196b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OXA9, FA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ell differentiatio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35317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OXB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86182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-myc, BCL-2 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29321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518b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ap1b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 dirty="0">
                          <a:effectLst/>
                          <a:latin typeface="Calibri (テーマの本文)"/>
                        </a:rPr>
                        <a:t>2295889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effectLst/>
                          <a:latin typeface="Calibri (テーマの本文)"/>
                        </a:rPr>
                        <a:t>hsa-miR-52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10b*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BUB1, PLK1, CCNA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12502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5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10b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TIP3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409648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e-cadheri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84719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syndecan-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57347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OXD1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29368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75308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OXD1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419107, 2035169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NCOR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ell differentiatio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21279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TIAM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044470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KLF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007507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6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5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has-mir-138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TWIST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417192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MND5A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 nuclear expor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 dirty="0">
                          <a:effectLst/>
                          <a:latin typeface="Calibri (テーマの本文)"/>
                        </a:rPr>
                        <a:t>2405721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EZH2,CDK6,E2F2, E2F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70755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serine/theronine kinase MST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48501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FAK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hemoresistan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43884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600" b="0" i="0" u="none" strike="noStrike">
                          <a:effectLst/>
                          <a:latin typeface="Calibri (テーマの本文)"/>
                        </a:rPr>
                        <a:t>SOX4, HIF-1α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38973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hoC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44643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FLOT1, FLOT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lipid raf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31982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NGAL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Wingdings"/>
                        </a:rPr>
                        <a:t>¡</a:t>
                      </a:r>
                      <a:endParaRPr lang="ja-JP" altLang="en-US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30083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BCR-ABL, CCND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leukogenesi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20850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CND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739938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p5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stem cell generatio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696098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FOSL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96936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l-GR" sz="600" b="0" i="0" u="none" strike="noStrike">
                          <a:effectLst/>
                          <a:latin typeface="Calibri (テーマの本文)"/>
                        </a:rPr>
                        <a:t>HIF-1α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87528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istone H2AX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DNA damage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69359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effectLst/>
                          <a:latin typeface="Calibri (テーマの本文)"/>
                        </a:rPr>
                        <a:t>hsa-mir-62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JMJD1A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istone  methylatio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 dirty="0">
                          <a:effectLst/>
                          <a:latin typeface="Calibri (テーマの本文)"/>
                        </a:rPr>
                        <a:t>2361914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8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effectLst/>
                          <a:latin typeface="Calibri (テーマの本文)"/>
                        </a:rPr>
                        <a:t>hsa-mir-138-1*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effectLst/>
                          <a:latin typeface="Calibri (テーマの本文)"/>
                        </a:rPr>
                        <a:t>hsa-mir-625-3p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drug resistant 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50697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600" b="0" i="0" u="none" strike="noStrike">
                          <a:effectLst/>
                          <a:latin typeface="Calibri (テーマの本文)"/>
                        </a:rPr>
                        <a:t>hsa-mir-450b-3p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422a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YP7A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035106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2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de-DE" sz="600" b="0" i="0" u="none" strike="noStrike" dirty="0">
                          <a:effectLst/>
                          <a:latin typeface="Calibri (テーマの本文)"/>
                        </a:rPr>
                        <a:t>hsa-miR-486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IGF, IGFR, PIK3R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Wingdings"/>
                        </a:rPr>
                        <a:t>¡</a:t>
                      </a:r>
                      <a:endParaRPr lang="ja-JP" altLang="en-US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98015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ARGHGAP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47476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YTLD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NF-KB activatio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24762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SIRT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98823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FOXO1, PETE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014247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CD4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-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947545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3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1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34c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NaNOG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403820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ME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92210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UNX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72073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ARg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mESC differentiation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09731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sGCB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03877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NOTCH1, NOTCH2, JAG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49897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ATF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47946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BMF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drug resistan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37063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RFR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97650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E2F3, BCL-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35125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-me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019830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13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4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3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15a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CNE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ell cycle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90035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ECK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17614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VEGF-A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Wingdings"/>
                        </a:rPr>
                        <a:t>¡</a:t>
                      </a:r>
                      <a:endParaRPr lang="ja-JP" altLang="en-US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angiogenesi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10418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CND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ell cycle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92282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FGF2, VEGF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Wingdings"/>
                        </a:rPr>
                        <a:t>¡</a:t>
                      </a:r>
                      <a:endParaRPr lang="ja-JP" altLang="en-US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angiogenesi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69221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CNB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57471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BCL-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463747, 1616626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DAC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transforamtion 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00231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FGF2 ( in CAF)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○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532615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yclin E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45437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UCP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insulin synthesi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146880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WNT3A, FGF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 dirty="0">
                          <a:effectLst/>
                          <a:latin typeface="Calibri (テーマの本文)"/>
                        </a:rPr>
                        <a:t>○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10605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BMI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990384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rowSpan="14">
                  <a:txBody>
                    <a:bodyPr/>
                    <a:lstStyle/>
                    <a:p>
                      <a:pPr algn="ctr" fontAlgn="ctr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15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14">
                  <a:txBody>
                    <a:bodyPr/>
                    <a:lstStyle/>
                    <a:p>
                      <a:pPr algn="ctr" fontAlgn="ctr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hsa-miR-148a</a:t>
                      </a:r>
                    </a:p>
                  </a:txBody>
                  <a:tcPr marL="5793" marR="5793" marT="5793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MET, snail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EM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401322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CKBR, BCL-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97537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SMAD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87310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WNT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○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EM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586122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OCK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EMT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670799, 2199441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RUNX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54998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 dirty="0">
                          <a:effectLst/>
                          <a:latin typeface="Calibri (テーマの本文)"/>
                        </a:rPr>
                        <a:t>MAFB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osteoclastogenesi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22515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WNT10B ( in CAF)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○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2890324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DC25B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ell cycle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709669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p2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55242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ERBB3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angiogenesis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355468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BCL-2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1455521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CAND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BFB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>
                          <a:effectLst/>
                          <a:latin typeface="Calibri (テーマの本文)"/>
                        </a:rPr>
                        <a:t>20820187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81101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MSK1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ro-RO" sz="600" b="0" i="0" u="none" strike="noStrike">
                          <a:effectLst/>
                          <a:latin typeface="Wingdings 2"/>
                        </a:rPr>
                        <a:t>Î</a:t>
                      </a:r>
                      <a:endParaRPr lang="ro-RO" sz="600" b="0" i="0" u="none" strike="noStrike">
                        <a:effectLst/>
                        <a:latin typeface="Calibri (テーマの本文)"/>
                      </a:endParaRP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 dirty="0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600" b="0" i="0" u="none" strike="noStrike">
                          <a:effectLst/>
                          <a:latin typeface="Calibri (テーマの本文)"/>
                        </a:rPr>
                        <a:t>　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600" b="0" i="0" u="none" strike="noStrike">
                          <a:effectLst/>
                          <a:latin typeface="Calibri (テーマの本文)"/>
                        </a:rPr>
                        <a:t>drug resistance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600" b="0" i="0" u="none" strike="noStrike" dirty="0">
                          <a:effectLst/>
                          <a:latin typeface="Calibri (テーマの本文)"/>
                        </a:rPr>
                        <a:t>20406806</a:t>
                      </a:r>
                    </a:p>
                  </a:txBody>
                  <a:tcPr marL="5793" marR="5793" marT="5793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87092" y="173247"/>
            <a:ext cx="24804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/>
              <a:t>Supplementary Table S3</a:t>
            </a:r>
            <a:endParaRPr kumimoji="1" lang="ja-JP" altLang="en-US" b="1" dirty="0"/>
          </a:p>
        </p:txBody>
      </p:sp>
      <p:sp>
        <p:nvSpPr>
          <p:cNvPr id="2" name="TextBox 1"/>
          <p:cNvSpPr txBox="1"/>
          <p:nvPr/>
        </p:nvSpPr>
        <p:spPr>
          <a:xfrm>
            <a:off x="1983560" y="8930614"/>
            <a:ext cx="550151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X : yes</a:t>
            </a:r>
          </a:p>
          <a:p>
            <a:r>
              <a:rPr lang="en-US" sz="1100" dirty="0" smtClean="0"/>
              <a:t>O : no</a:t>
            </a:r>
            <a:endParaRPr lang="en-US" sz="1100" dirty="0"/>
          </a:p>
        </p:txBody>
      </p:sp>
    </p:spTree>
    <p:extLst>
      <p:ext uri="{BB962C8B-B14F-4D97-AF65-F5344CB8AC3E}">
        <p14:creationId xmlns:p14="http://schemas.microsoft.com/office/powerpoint/2010/main" val="14299171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443</Words>
  <Application>Microsoft Office PowerPoint</Application>
  <PresentationFormat>A4 Paper (210x297 mm)</PresentationFormat>
  <Paragraphs>83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8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10" baseType="lpstr">
      <vt:lpstr>游ゴシック</vt:lpstr>
      <vt:lpstr>游ゴシック Light</vt:lpstr>
      <vt:lpstr>Arial</vt:lpstr>
      <vt:lpstr>Calibri</vt:lpstr>
      <vt:lpstr>Calibri (テーマの本文)</vt:lpstr>
      <vt:lpstr>Calibri Light</vt:lpstr>
      <vt:lpstr>Wingdings</vt:lpstr>
      <vt:lpstr>Wingdings 2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sei Kudo</dc:creator>
  <cp:lastModifiedBy>Chanitra Thuwajit</cp:lastModifiedBy>
  <cp:revision>2</cp:revision>
  <dcterms:created xsi:type="dcterms:W3CDTF">2017-05-18T06:10:31Z</dcterms:created>
  <dcterms:modified xsi:type="dcterms:W3CDTF">2017-09-01T05:51:13Z</dcterms:modified>
</cp:coreProperties>
</file>